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98106-A358-4895-82BC-2205E53626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C7FCF-9FAF-4DAF-B683-5907A31FF8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E70043-47AE-45EF-B8C9-63E68485AC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161C5-FF48-4ED8-9DCA-36894DF73D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72917-6761-4D2B-A7E4-8AD79B5198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4CF190-417C-48D0-B639-9F3DFD7458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23E39-DAC0-4B24-A6F5-0527CBD591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71D3F-B7D0-4F2B-896B-D90BB16CB2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69B98-1A73-461D-B8DE-100726698E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221D68-9934-44D0-B6B2-A7ADAC5BC8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EEFEF-19E7-479A-9466-D90D9E896A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99B45-0C1A-4080-9F7D-C6C678B19B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24E288-456F-4874-A5C3-D24D77DB88D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6200000">
            <a:off x="3095640" y="1704600"/>
            <a:ext cx="933480" cy="2667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657600" y="601560"/>
            <a:ext cx="1905120" cy="304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990720" y="601560"/>
            <a:ext cx="1981080" cy="304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176040" y="1728360"/>
            <a:ext cx="933480" cy="2188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4948200" y="1613880"/>
            <a:ext cx="933480" cy="2955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2357280" y="1613880"/>
            <a:ext cx="933480" cy="295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3639960" y="3271680"/>
            <a:ext cx="2227320" cy="213840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 rot="16200000">
            <a:off x="3100320" y="4204800"/>
            <a:ext cx="933480" cy="295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2"/>
          <a:stretch/>
        </p:blipFill>
        <p:spPr>
          <a:xfrm>
            <a:off x="973080" y="3267000"/>
            <a:ext cx="2227320" cy="213840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 rot="16200000">
            <a:off x="442800" y="4204800"/>
            <a:ext cx="933480" cy="295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3"/>
          <a:stretch/>
        </p:blipFill>
        <p:spPr>
          <a:xfrm>
            <a:off x="3639960" y="585720"/>
            <a:ext cx="2227320" cy="213840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 rot="16200000">
            <a:off x="2644560" y="1518840"/>
            <a:ext cx="933480" cy="295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4"/>
          <a:stretch/>
        </p:blipFill>
        <p:spPr>
          <a:xfrm>
            <a:off x="973080" y="581040"/>
            <a:ext cx="2227320" cy="213840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 rot="16200000">
            <a:off x="458640" y="1552320"/>
            <a:ext cx="93348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295880" y="5353200"/>
            <a:ext cx="933480" cy="295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657440" y="5353200"/>
            <a:ext cx="933480" cy="295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259160" y="2666880"/>
            <a:ext cx="933480" cy="2955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733920" y="457200"/>
            <a:ext cx="1904760" cy="304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219320" y="3124080"/>
            <a:ext cx="2209680" cy="304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886200" y="3124080"/>
            <a:ext cx="2057400" cy="304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278000" y="438120"/>
            <a:ext cx="1981080" cy="304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818720" y="493560"/>
            <a:ext cx="72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ell cyc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388760" y="496800"/>
            <a:ext cx="74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ibosom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277640" y="3182760"/>
            <a:ext cx="183888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minoacyl-tRNA biosynthe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108680" y="3182760"/>
            <a:ext cx="1448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yrimidine metabolis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582560" y="2657520"/>
            <a:ext cx="933480" cy="295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584360" y="2647800"/>
            <a:ext cx="68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uster 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195800" y="2647800"/>
            <a:ext cx="68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uster 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622520" y="5334120"/>
            <a:ext cx="68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uster 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281480" y="5334120"/>
            <a:ext cx="68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uster 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456480" y="1566000"/>
            <a:ext cx="97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uster 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rot="16200000">
            <a:off x="3199680" y="171144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uster 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623160" y="440064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uster 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rot="16200000">
            <a:off x="3083400" y="4248360"/>
            <a:ext cx="97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uster 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31T11:50:47Z</dcterms:created>
  <dc:creator>marcelk</dc:creator>
  <dc:description/>
  <dc:language>en-US</dc:language>
  <cp:lastModifiedBy>marcelk</cp:lastModifiedBy>
  <dcterms:modified xsi:type="dcterms:W3CDTF">2008-02-15T13:45:11Z</dcterms:modified>
  <cp:revision>3</cp:revision>
  <dc:subject/>
  <dc:title>Slide 1</dc:title>
</cp:coreProperties>
</file>